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4B3DB1-D9A0-48AB-83F5-5055A124346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A46FF5-1291-4498-ACAE-77824242DA6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B3D569-C724-49A3-B0C7-49FA0EDD432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AC904C-434C-4DFC-BD14-F704F15EB8B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A9663B-AECA-4F50-A704-1ACC2A74AC7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2CB9B5-A5E3-4EE1-A2DF-ADAE87688B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05E134-4D50-491E-89E9-E85891CEA32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C33346-0B34-4C1B-B1DB-82C2B07557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92FB2E-3562-4452-AB80-56A94D8C95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A9E58E-EA39-4503-89D6-B911015602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EFDC6E-6D63-47ED-9EB8-802BCDB785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BD07F8-C016-47AF-AE7F-DCF12BFED7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A9574E5-44DF-4D66-8F50-A6EDF65328F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908000" y="333360"/>
            <a:ext cx="5838840" cy="4762440"/>
            <a:chOff x="1908000" y="333360"/>
            <a:chExt cx="5838840" cy="4762440"/>
          </a:xfrm>
        </p:grpSpPr>
        <p:grpSp>
          <p:nvGrpSpPr>
            <p:cNvPr id="42" name=""/>
            <p:cNvGrpSpPr/>
            <p:nvPr/>
          </p:nvGrpSpPr>
          <p:grpSpPr>
            <a:xfrm>
              <a:off x="1908000" y="333360"/>
              <a:ext cx="5838840" cy="4762440"/>
              <a:chOff x="1908000" y="333360"/>
              <a:chExt cx="5838840" cy="4762440"/>
            </a:xfrm>
          </p:grpSpPr>
          <p:pic>
            <p:nvPicPr>
              <p:cNvPr id="43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1908000" y="333360"/>
                <a:ext cx="5838840" cy="4762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4" name=""/>
              <p:cNvSpPr/>
              <p:nvPr/>
            </p:nvSpPr>
            <p:spPr>
              <a:xfrm>
                <a:off x="4427280" y="2060280"/>
                <a:ext cx="936720" cy="5047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5" name=""/>
            <p:cNvSpPr/>
            <p:nvPr/>
          </p:nvSpPr>
          <p:spPr>
            <a:xfrm>
              <a:off x="4789080" y="2228760"/>
              <a:ext cx="942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6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=0.717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6" name=""/>
          <p:cNvSpPr/>
          <p:nvPr/>
        </p:nvSpPr>
        <p:spPr>
          <a:xfrm>
            <a:off x="900000" y="5589720"/>
            <a:ext cx="78487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Figure S1.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 Kaplan-Meier curve for progression free survival according to the level of RUNX2 IHC intensity in tumor samples of 52 serous EOC patients.</a:t>
            </a:r>
            <a:r>
              <a:rPr b="0" lang="fr-CA" sz="1400" spc="-1" strike="noStrike">
                <a:solidFill>
                  <a:srgbClr val="000000"/>
                </a:solidFill>
                <a:latin typeface="Arial"/>
                <a:ea typeface="MS PGothic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25T19:18:07Z</dcterms:created>
  <dc:creator>dbatch</dc:creator>
  <dc:description/>
  <dc:language>en-US</dc:language>
  <cp:lastModifiedBy>Dbatch</cp:lastModifiedBy>
  <dcterms:modified xsi:type="dcterms:W3CDTF">2013-09-10T16:27:26Z</dcterms:modified>
  <cp:revision>14</cp:revision>
  <dc:subject/>
  <dc:title>Diapositive 1</dc:title>
</cp:coreProperties>
</file>